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204186"/>
            <a:ext cx="10233660" cy="881487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Efficacy and safety of dapagliflozin in children with kidney disease:         	real-world data</a:t>
            </a:r>
            <a:endParaRPr lang="en-GB" sz="2800" b="1" dirty="0">
              <a:solidFill>
                <a:schemeClr val="bg1"/>
              </a:solidFill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</a:t>
            </a:r>
            <a:r>
              <a:rPr lang="en-US" dirty="0">
                <a:solidFill>
                  <a:schemeClr val="bg1"/>
                </a:solidFill>
              </a:rPr>
              <a:t>o report the effect of dapagliflozin in children with kidney diseas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Choi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Dapagliflozin has not been associated with serious side effects. Further prospective clinical trials are needed to confirm the efficacy and safety of dapagliflozin in children with kidney disease.</a:t>
            </a: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3ED4A39-C923-33EB-91E8-8C6B078A90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078" y="1663176"/>
            <a:ext cx="11863844" cy="38232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3</TotalTime>
  <Words>6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2</cp:revision>
  <dcterms:created xsi:type="dcterms:W3CDTF">2019-06-13T12:30:18Z</dcterms:created>
  <dcterms:modified xsi:type="dcterms:W3CDTF">2024-07-25T19:30:42Z</dcterms:modified>
</cp:coreProperties>
</file>